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193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8607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738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999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781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278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412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886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073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02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9384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92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295A4-88AD-4D54-A649-9D83D04CDA35}" type="datetimeFigureOut">
              <a:rPr kumimoji="1" lang="ja-JP" altLang="en-US" smtClean="0"/>
              <a:t>2024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FA20A-BD75-467A-8E4B-264417AD6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793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2C336E2-5732-0021-6D70-008CCA357C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4989933"/>
              </p:ext>
            </p:extLst>
          </p:nvPr>
        </p:nvGraphicFramePr>
        <p:xfrm>
          <a:off x="689508" y="1998858"/>
          <a:ext cx="5478983" cy="4037296"/>
        </p:xfrm>
        <a:graphic>
          <a:graphicData uri="http://schemas.openxmlformats.org/drawingml/2006/table">
            <a:tbl>
              <a:tblPr/>
              <a:tblGrid>
                <a:gridCol w="499121">
                  <a:extLst>
                    <a:ext uri="{9D8B030D-6E8A-4147-A177-3AD203B41FA5}">
                      <a16:colId xmlns:a16="http://schemas.microsoft.com/office/drawing/2014/main" val="3076463330"/>
                    </a:ext>
                  </a:extLst>
                </a:gridCol>
                <a:gridCol w="1213770">
                  <a:extLst>
                    <a:ext uri="{9D8B030D-6E8A-4147-A177-3AD203B41FA5}">
                      <a16:colId xmlns:a16="http://schemas.microsoft.com/office/drawing/2014/main" val="2363537866"/>
                    </a:ext>
                  </a:extLst>
                </a:gridCol>
                <a:gridCol w="1883046">
                  <a:extLst>
                    <a:ext uri="{9D8B030D-6E8A-4147-A177-3AD203B41FA5}">
                      <a16:colId xmlns:a16="http://schemas.microsoft.com/office/drawing/2014/main" val="3916071250"/>
                    </a:ext>
                  </a:extLst>
                </a:gridCol>
                <a:gridCol w="1883046">
                  <a:extLst>
                    <a:ext uri="{9D8B030D-6E8A-4147-A177-3AD203B41FA5}">
                      <a16:colId xmlns:a16="http://schemas.microsoft.com/office/drawing/2014/main" val="496913372"/>
                    </a:ext>
                  </a:extLst>
                </a:gridCol>
              </a:tblGrid>
              <a:tr h="3242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tual result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9781801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isease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ealth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4519528"/>
                  </a:ext>
                </a:extLst>
              </a:tr>
              <a:tr h="32424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al-time PC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sitiv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a) TP (true positive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b) FP (false positive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2864526"/>
                  </a:ext>
                </a:extLst>
              </a:tr>
              <a:tr h="32424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egativ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c) FN (false negative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d) TN (truse negative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3769652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147277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nsitivity (= Recal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/(a+c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3624313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pecific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/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+d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3124604"/>
                  </a:ext>
                </a:extLst>
              </a:tr>
              <a:tr h="469504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ositive predictive rate, PPV (=precision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/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+b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179755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egative predictive rate, NP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/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+d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493856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lse positive r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/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+d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 =1 -specific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2847305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lse negative r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/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+c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) =1-sensitiv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3100054"/>
                  </a:ext>
                </a:extLst>
              </a:tr>
              <a:tr h="324243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curacy (=efficiency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a+d)/(a+b+c+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2769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8C7C185-602F-6F9A-8127-F8BFE3CEDF8E}"/>
              </a:ext>
            </a:extLst>
          </p:cNvPr>
          <p:cNvSpPr txBox="1"/>
          <p:nvPr/>
        </p:nvSpPr>
        <p:spPr>
          <a:xfrm>
            <a:off x="816745" y="570233"/>
            <a:ext cx="52245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 Figure 1.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ross-table and detection performance indicator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967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22</TotalTime>
  <Words>136</Words>
  <Application>Microsoft Office PowerPoint</Application>
  <PresentationFormat>A4 210 x 297 mm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8</cp:revision>
  <dcterms:created xsi:type="dcterms:W3CDTF">2024-05-22T04:00:38Z</dcterms:created>
  <dcterms:modified xsi:type="dcterms:W3CDTF">2024-07-19T09:13:12Z</dcterms:modified>
</cp:coreProperties>
</file>